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59" r:id="rId2"/>
    <p:sldId id="256" r:id="rId3"/>
    <p:sldId id="258" r:id="rId4"/>
    <p:sldId id="257" r:id="rId5"/>
    <p:sldId id="260" r:id="rId6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188"/>
    <p:restoredTop sz="94689"/>
  </p:normalViewPr>
  <p:slideViewPr>
    <p:cSldViewPr snapToGrid="0" snapToObjects="1">
      <p:cViewPr>
        <p:scale>
          <a:sx n="209" d="100"/>
          <a:sy n="209" d="100"/>
        </p:scale>
        <p:origin x="-64" y="-1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90821F-5FC8-4A49-840C-BC83FC870B31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A86279-CC92-5F4C-BEC4-5A6935AE29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32739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A86279-CC92-5F4C-BEC4-5A6935AE29F4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91759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A86279-CC92-5F4C-BEC4-5A6935AE29F4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36572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FD11F-913B-9C48-8634-D1A839711900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9322-BBC5-AD40-A991-273AB4EE1C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5299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FD11F-913B-9C48-8634-D1A839711900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9322-BBC5-AD40-A991-273AB4EE1C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6422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FD11F-913B-9C48-8634-D1A839711900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9322-BBC5-AD40-A991-273AB4EE1C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7050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FD11F-913B-9C48-8634-D1A839711900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9322-BBC5-AD40-A991-273AB4EE1C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8651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FD11F-913B-9C48-8634-D1A839711900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9322-BBC5-AD40-A991-273AB4EE1C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9770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FD11F-913B-9C48-8634-D1A839711900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9322-BBC5-AD40-A991-273AB4EE1C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1425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FD11F-913B-9C48-8634-D1A839711900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9322-BBC5-AD40-A991-273AB4EE1C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900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FD11F-913B-9C48-8634-D1A839711900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9322-BBC5-AD40-A991-273AB4EE1C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0763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FD11F-913B-9C48-8634-D1A839711900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9322-BBC5-AD40-A991-273AB4EE1C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4444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FD11F-913B-9C48-8634-D1A839711900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9322-BBC5-AD40-A991-273AB4EE1C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0505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FD11F-913B-9C48-8634-D1A839711900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9322-BBC5-AD40-A991-273AB4EE1C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23787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BFD11F-913B-9C48-8634-D1A839711900}" type="datetimeFigureOut">
              <a:rPr lang="de-DE" smtClean="0"/>
              <a:t>29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29322-BBC5-AD40-A991-273AB4EE1C6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6906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35AB1EBC-B957-EC4B-BB6E-BD4C0B6BD19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50"/>
          <a:stretch/>
        </p:blipFill>
        <p:spPr>
          <a:xfrm>
            <a:off x="553121" y="862527"/>
            <a:ext cx="5880548" cy="3721455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1C865740-B03F-E24B-94ED-7E50239A4A2D}"/>
              </a:ext>
            </a:extLst>
          </p:cNvPr>
          <p:cNvSpPr txBox="1"/>
          <p:nvPr/>
        </p:nvSpPr>
        <p:spPr>
          <a:xfrm rot="16200000">
            <a:off x="-212542" y="3480545"/>
            <a:ext cx="10583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preference baseline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6DA87DB1-31A3-A543-882B-7604FF67AAF6}"/>
              </a:ext>
            </a:extLst>
          </p:cNvPr>
          <p:cNvSpPr txBox="1"/>
          <p:nvPr/>
        </p:nvSpPr>
        <p:spPr>
          <a:xfrm rot="16200000">
            <a:off x="-212542" y="1651745"/>
            <a:ext cx="10583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preference baseline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B2A8D892-D125-C941-8497-741F561CE235}"/>
              </a:ext>
            </a:extLst>
          </p:cNvPr>
          <p:cNvSpPr txBox="1"/>
          <p:nvPr/>
        </p:nvSpPr>
        <p:spPr>
          <a:xfrm rot="16200000">
            <a:off x="313038" y="3834008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E054E5F7-6E25-8547-A405-FFF6F34CDCE3}"/>
              </a:ext>
            </a:extLst>
          </p:cNvPr>
          <p:cNvSpPr txBox="1"/>
          <p:nvPr/>
        </p:nvSpPr>
        <p:spPr>
          <a:xfrm rot="16200000">
            <a:off x="313038" y="1298282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D02FA5D6-BC18-414D-A50E-F4A7CCD2CB68}"/>
              </a:ext>
            </a:extLst>
          </p:cNvPr>
          <p:cNvSpPr txBox="1"/>
          <p:nvPr/>
        </p:nvSpPr>
        <p:spPr>
          <a:xfrm rot="16200000">
            <a:off x="313038" y="2005208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570BD734-E762-B046-82F2-F16879209143}"/>
              </a:ext>
            </a:extLst>
          </p:cNvPr>
          <p:cNvSpPr txBox="1"/>
          <p:nvPr/>
        </p:nvSpPr>
        <p:spPr>
          <a:xfrm rot="16200000">
            <a:off x="313038" y="3152889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E3744696-7D74-0B46-83A5-4DC2D6FF6209}"/>
              </a:ext>
            </a:extLst>
          </p:cNvPr>
          <p:cNvSpPr txBox="1"/>
          <p:nvPr/>
        </p:nvSpPr>
        <p:spPr>
          <a:xfrm>
            <a:off x="297035" y="145605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3835222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1E3C44C9-C92F-2B4B-AD00-9A603126AA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8432319"/>
              </p:ext>
            </p:extLst>
          </p:nvPr>
        </p:nvGraphicFramePr>
        <p:xfrm>
          <a:off x="33342" y="650378"/>
          <a:ext cx="6791316" cy="3794100"/>
        </p:xfrm>
        <a:graphic>
          <a:graphicData uri="http://schemas.openxmlformats.org/drawingml/2006/table">
            <a:tbl>
              <a:tblPr/>
              <a:tblGrid>
                <a:gridCol w="485094">
                  <a:extLst>
                    <a:ext uri="{9D8B030D-6E8A-4147-A177-3AD203B41FA5}">
                      <a16:colId xmlns:a16="http://schemas.microsoft.com/office/drawing/2014/main" val="1591016043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2492609659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3412461553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2332032094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4153333579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2543400259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1757833992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2676092352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2585400117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3286591425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1525001492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2919444059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1866180847"/>
                    </a:ext>
                  </a:extLst>
                </a:gridCol>
                <a:gridCol w="485094">
                  <a:extLst>
                    <a:ext uri="{9D8B030D-6E8A-4147-A177-3AD203B41FA5}">
                      <a16:colId xmlns:a16="http://schemas.microsoft.com/office/drawing/2014/main" val="347673747"/>
                    </a:ext>
                  </a:extLst>
                </a:gridCol>
              </a:tblGrid>
              <a:tr h="11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ales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=1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emales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=1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9848851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ohort 1 and 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ood 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C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ood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C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4127151"/>
                  </a:ext>
                </a:extLst>
              </a:tr>
              <a:tr h="1105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reference choice test 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baseline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baseline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7359718"/>
                  </a:ext>
                </a:extLst>
              </a:tr>
              <a:tr h="117000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ean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EM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ean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EM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ean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EM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ean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EM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170978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emoglobin (g/dL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6,73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,34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,86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,09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,63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,8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6,64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,49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8566204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RBC (10*6/µL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,69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9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,18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,03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,16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,36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,7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,33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431214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BC (10*3/µL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,09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,1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,2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,50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,4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,5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,51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,13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4226667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T (10*3/µL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39,00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08,09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87,2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12,04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64,46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45,9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21,4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70,5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1738054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ematokrit(%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0,81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,00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7,1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,10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2,4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,64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0,1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,79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1226586"/>
                  </a:ext>
                </a:extLst>
              </a:tr>
              <a:tr h="104000"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ean corpuscular volume (fL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5,4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,28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2,7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,21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6,3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91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3,6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7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3464505"/>
                  </a:ext>
                </a:extLst>
              </a:tr>
              <a:tr h="104000">
                <a:tc gridSpan="4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ean corpuscular hemoglobin (pg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5,6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36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5,1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43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5,98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39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5,48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2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9960393"/>
                  </a:ext>
                </a:extLst>
              </a:tr>
              <a:tr h="104000">
                <a:tc gridSpan="5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ean corpuscular hemoglobin concentration (g/dL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4,46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4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5,3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5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4,4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7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5,46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49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2064779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Glucose (mg/dL) 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73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6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0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6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0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9189128"/>
                  </a:ext>
                </a:extLst>
              </a:tr>
              <a:tr h="104000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9283786"/>
                  </a:ext>
                </a:extLst>
              </a:tr>
              <a:tr h="104000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9005292"/>
                  </a:ext>
                </a:extLst>
              </a:tr>
              <a:tr h="11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emales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=4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5699429"/>
                  </a:ext>
                </a:extLst>
              </a:tr>
              <a:tr h="104000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ohort 4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ood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C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1408489"/>
                  </a:ext>
                </a:extLst>
              </a:tr>
              <a:tr h="11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C in DVC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7282159"/>
                  </a:ext>
                </a:extLst>
              </a:tr>
              <a:tr h="117000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ean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EM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ean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EM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3424355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emoglobin (g/dL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6,24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,08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,3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,1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7223237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RBC (10*6/µL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,06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,2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,9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,18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7613920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BC (10*3/µL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,61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,41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,81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,16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248284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T (10*3/µL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98,38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29,0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54,7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20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9949190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ematokrit(%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5,48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,5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0,31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,9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6443929"/>
                  </a:ext>
                </a:extLst>
              </a:tr>
              <a:tr h="104000"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ean corpuscular volume (fL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5,25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46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5,18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8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1983099"/>
                  </a:ext>
                </a:extLst>
              </a:tr>
              <a:tr h="104000">
                <a:tc gridSpan="4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ean corpuscular hemoglobin (pg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6,14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2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0,9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32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1385067"/>
                  </a:ext>
                </a:extLst>
              </a:tr>
              <a:tr h="104000">
                <a:tc gridSpan="5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ean corpuscular hemoglobin concentration (g/dL)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5,68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,44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5,21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,1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7680288"/>
                  </a:ext>
                </a:extLst>
              </a:tr>
              <a:tr h="104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Glucose (mg/dL) 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9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7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1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</a:t>
                      </a:r>
                    </a:p>
                  </a:txBody>
                  <a:tcPr marL="4875" marR="4875" marT="487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229825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CE16DC57-A1CD-484B-A54E-12A217BACFBA}"/>
              </a:ext>
            </a:extLst>
          </p:cNvPr>
          <p:cNvSpPr txBox="1"/>
          <p:nvPr/>
        </p:nvSpPr>
        <p:spPr>
          <a:xfrm>
            <a:off x="297035" y="145605"/>
            <a:ext cx="988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</a:p>
        </p:txBody>
      </p:sp>
    </p:spTree>
    <p:extLst>
      <p:ext uri="{BB962C8B-B14F-4D97-AF65-F5344CB8AC3E}">
        <p14:creationId xmlns:p14="http://schemas.microsoft.com/office/powerpoint/2010/main" val="577622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503695B5-7A53-9647-B68D-7DEDEBCC134E}"/>
              </a:ext>
            </a:extLst>
          </p:cNvPr>
          <p:cNvSpPr txBox="1"/>
          <p:nvPr/>
        </p:nvSpPr>
        <p:spPr>
          <a:xfrm>
            <a:off x="297035" y="145605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B6B462DE-A788-824B-954F-CA11A0FDD9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3235" y="698543"/>
            <a:ext cx="3941590" cy="1733395"/>
          </a:xfrm>
          <a:prstGeom prst="rect">
            <a:avLst/>
          </a:prstGeom>
        </p:spPr>
      </p:pic>
      <p:graphicFrame>
        <p:nvGraphicFramePr>
          <p:cNvPr id="6" name="Tabelle 5">
            <a:extLst>
              <a:ext uri="{FF2B5EF4-FFF2-40B4-BE49-F238E27FC236}">
                <a16:creationId xmlns:a16="http://schemas.microsoft.com/office/drawing/2014/main" id="{8CAB585B-8F76-9C44-A4A3-18505091DF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5364962"/>
              </p:ext>
            </p:extLst>
          </p:nvPr>
        </p:nvGraphicFramePr>
        <p:xfrm>
          <a:off x="373235" y="2586969"/>
          <a:ext cx="3976360" cy="613430"/>
        </p:xfrm>
        <a:graphic>
          <a:graphicData uri="http://schemas.openxmlformats.org/drawingml/2006/table">
            <a:tbl>
              <a:tblPr/>
              <a:tblGrid>
                <a:gridCol w="795272">
                  <a:extLst>
                    <a:ext uri="{9D8B030D-6E8A-4147-A177-3AD203B41FA5}">
                      <a16:colId xmlns:a16="http://schemas.microsoft.com/office/drawing/2014/main" val="1663595062"/>
                    </a:ext>
                  </a:extLst>
                </a:gridCol>
                <a:gridCol w="795272">
                  <a:extLst>
                    <a:ext uri="{9D8B030D-6E8A-4147-A177-3AD203B41FA5}">
                      <a16:colId xmlns:a16="http://schemas.microsoft.com/office/drawing/2014/main" val="1752319205"/>
                    </a:ext>
                  </a:extLst>
                </a:gridCol>
                <a:gridCol w="795272">
                  <a:extLst>
                    <a:ext uri="{9D8B030D-6E8A-4147-A177-3AD203B41FA5}">
                      <a16:colId xmlns:a16="http://schemas.microsoft.com/office/drawing/2014/main" val="1537140730"/>
                    </a:ext>
                  </a:extLst>
                </a:gridCol>
                <a:gridCol w="795272">
                  <a:extLst>
                    <a:ext uri="{9D8B030D-6E8A-4147-A177-3AD203B41FA5}">
                      <a16:colId xmlns:a16="http://schemas.microsoft.com/office/drawing/2014/main" val="707193933"/>
                    </a:ext>
                  </a:extLst>
                </a:gridCol>
                <a:gridCol w="795272">
                  <a:extLst>
                    <a:ext uri="{9D8B030D-6E8A-4147-A177-3AD203B41FA5}">
                      <a16:colId xmlns:a16="http://schemas.microsoft.com/office/drawing/2014/main" val="3747884855"/>
                    </a:ext>
                  </a:extLst>
                </a:gridCol>
              </a:tblGrid>
              <a:tr h="207994"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</a:rPr>
                        <a:t>bedding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</a:rPr>
                        <a:t>corneal fluoresce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</a:rPr>
                        <a:t>total ey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521277"/>
                  </a:ext>
                </a:extLst>
              </a:tr>
              <a:tr h="197442"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</a:rPr>
                        <a:t>woo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</a:rPr>
                        <a:t>grade 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</a:rPr>
                        <a:t>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9455525"/>
                  </a:ext>
                </a:extLst>
              </a:tr>
              <a:tr h="207994"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</a:rPr>
                        <a:t>P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</a:rPr>
                        <a:t>grade 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</a:rPr>
                        <a:t>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24272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598664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26FD59BC-4C35-844E-BA5B-81FC4EFA192D}"/>
              </a:ext>
            </a:extLst>
          </p:cNvPr>
          <p:cNvSpPr txBox="1"/>
          <p:nvPr/>
        </p:nvSpPr>
        <p:spPr>
          <a:xfrm>
            <a:off x="297035" y="145605"/>
            <a:ext cx="988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23797945-9237-B944-BE37-F77A79D048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533" y="739099"/>
            <a:ext cx="283282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</a:pPr>
            <a:r>
              <a:rPr kumimoji="0" lang="en-US" altLang="de-DE" sz="900" b="1" i="0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lth check – criteria for the animal’s evaluation </a:t>
            </a:r>
            <a:endParaRPr kumimoji="0" lang="en-US" altLang="de-DE" sz="1800" b="0" i="0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5652E84F-50D4-A542-A830-9FE08BDAB377}"/>
              </a:ext>
            </a:extLst>
          </p:cNvPr>
          <p:cNvSpPr/>
          <p:nvPr/>
        </p:nvSpPr>
        <p:spPr>
          <a:xfrm>
            <a:off x="181533" y="5316071"/>
            <a:ext cx="9401175" cy="20621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 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Depending on the criterion, the evaluation matrix was rated as follows: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 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0 = Animal regularly corresponds to the strain and sex-specific characteristics of healthy animals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1 = Animal shows slight deviations which do not require additional observation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2 = Animal shows deviations which require additional observation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3 = Animal shows deviations that regularly require additional observation or one-time veterinary intervention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4 = Animal shows deviations that require immediate veterinary intervention/termination criterion/death 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 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The nutritional status (body condition score = BCS) was rated with points between 1-5: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 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1 = emaciated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2 = under-conditioned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3 = well-conditioned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4 = over-conditioned </a:t>
            </a:r>
            <a:endParaRPr lang="de-DE" sz="9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5 = obese</a:t>
            </a:r>
            <a:endParaRPr lang="de-DE" sz="900" dirty="0">
              <a:effectLst/>
              <a:latin typeface="Palatino Linotype" panose="02040502050505030304" pitchFamily="18" charset="0"/>
              <a:ea typeface="Times New Roman" panose="02020603050405020304" pitchFamily="18" charset="0"/>
            </a:endParaRPr>
          </a:p>
        </p:txBody>
      </p:sp>
      <p:graphicFrame>
        <p:nvGraphicFramePr>
          <p:cNvPr id="9" name="Tabelle 8">
            <a:extLst>
              <a:ext uri="{FF2B5EF4-FFF2-40B4-BE49-F238E27FC236}">
                <a16:creationId xmlns:a16="http://schemas.microsoft.com/office/drawing/2014/main" id="{F2E06D7C-FF2C-5543-9407-1D5004B6294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842566"/>
              </p:ext>
            </p:extLst>
          </p:nvPr>
        </p:nvGraphicFramePr>
        <p:xfrm>
          <a:off x="297035" y="1037562"/>
          <a:ext cx="4343400" cy="420941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435100">
                  <a:extLst>
                    <a:ext uri="{9D8B030D-6E8A-4147-A177-3AD203B41FA5}">
                      <a16:colId xmlns:a16="http://schemas.microsoft.com/office/drawing/2014/main" val="1496465528"/>
                    </a:ext>
                  </a:extLst>
                </a:gridCol>
                <a:gridCol w="1908300">
                  <a:extLst>
                    <a:ext uri="{9D8B030D-6E8A-4147-A177-3AD203B41FA5}">
                      <a16:colId xmlns:a16="http://schemas.microsoft.com/office/drawing/2014/main" val="2156369817"/>
                    </a:ext>
                  </a:extLst>
                </a:gridCol>
              </a:tblGrid>
              <a:tr h="327660">
                <a:tc>
                  <a:txBody>
                    <a:bodyPr/>
                    <a:lstStyle/>
                    <a:p>
                      <a:pPr algn="just"/>
                      <a:r>
                        <a:rPr lang="en-US" sz="9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Fur</a:t>
                      </a:r>
                      <a:endParaRPr lang="de-DE" sz="1000" b="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b="0" kern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The fur was examined for gloss, color, moisture content and completeness</a:t>
                      </a:r>
                      <a:endParaRPr lang="de-DE" sz="1000" b="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102914"/>
                  </a:ext>
                </a:extLst>
              </a:tr>
              <a:tr h="327660">
                <a:tc>
                  <a:txBody>
                    <a:bodyPr/>
                    <a:lstStyle/>
                    <a:p>
                      <a:pPr algn="just"/>
                      <a:r>
                        <a:rPr lang="en-US" sz="9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Skin</a:t>
                      </a:r>
                      <a:endParaRPr lang="de-DE" sz="1000" b="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tabLst>
                          <a:tab pos="355600" algn="l"/>
                          <a:tab pos="711200" algn="l"/>
                          <a:tab pos="1066800" algn="l"/>
                          <a:tab pos="1422400" algn="l"/>
                          <a:tab pos="1778000" algn="l"/>
                          <a:tab pos="2133600" algn="l"/>
                          <a:tab pos="2489200" algn="l"/>
                          <a:tab pos="2844800" algn="l"/>
                          <a:tab pos="3200400" algn="l"/>
                          <a:tab pos="3556000" algn="l"/>
                          <a:tab pos="3911600" algn="l"/>
                          <a:tab pos="4267200" algn="l"/>
                        </a:tabLs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The skin on the head and limbs was assessed for color changes and injuries</a:t>
                      </a:r>
                      <a:endParaRPr lang="de-DE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3581208"/>
                  </a:ext>
                </a:extLst>
              </a:tr>
              <a:tr h="327660">
                <a:tc>
                  <a:txBody>
                    <a:bodyPr/>
                    <a:lstStyle/>
                    <a:p>
                      <a:pPr algn="just"/>
                      <a:r>
                        <a:rPr lang="en-US" sz="9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ye, Eyelids </a:t>
                      </a:r>
                      <a:endParaRPr lang="de-DE" sz="1000" b="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tabLst>
                          <a:tab pos="355600" algn="l"/>
                          <a:tab pos="711200" algn="l"/>
                          <a:tab pos="1066800" algn="l"/>
                          <a:tab pos="1422400" algn="l"/>
                          <a:tab pos="1778000" algn="l"/>
                          <a:tab pos="2133600" algn="l"/>
                          <a:tab pos="2489200" algn="l"/>
                          <a:tab pos="2844800" algn="l"/>
                          <a:tab pos="3200400" algn="l"/>
                          <a:tab pos="3556000" algn="l"/>
                          <a:tab pos="3911600" algn="l"/>
                          <a:tab pos="4267200" algn="l"/>
                        </a:tabLst>
                      </a:pPr>
                      <a:r>
                        <a:rPr lang="en-US" sz="9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yes and eyelids were examined for deposits, swelling and injuries</a:t>
                      </a:r>
                      <a:endParaRPr lang="de-DE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3045086"/>
                  </a:ext>
                </a:extLst>
              </a:tr>
              <a:tr h="474345">
                <a:tc>
                  <a:txBody>
                    <a:bodyPr/>
                    <a:lstStyle/>
                    <a:p>
                      <a:pPr algn="just"/>
                      <a:r>
                        <a:rPr lang="en-US" sz="9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Legs and tail</a:t>
                      </a:r>
                      <a:endParaRPr lang="de-DE" sz="1000" b="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tabLst>
                          <a:tab pos="355600" algn="l"/>
                          <a:tab pos="711200" algn="l"/>
                          <a:tab pos="1066800" algn="l"/>
                          <a:tab pos="1422400" algn="l"/>
                          <a:tab pos="1778000" algn="l"/>
                          <a:tab pos="2133600" algn="l"/>
                          <a:tab pos="2489200" algn="l"/>
                          <a:tab pos="2844800" algn="l"/>
                          <a:tab pos="3200400" algn="l"/>
                          <a:tab pos="3556000" algn="l"/>
                          <a:tab pos="3911600" algn="l"/>
                          <a:tab pos="4267200" algn="l"/>
                        </a:tabLs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The limbs and tail were examined for color changes, mobility, swelling and injuries  </a:t>
                      </a:r>
                      <a:endParaRPr lang="de-DE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6218267"/>
                  </a:ext>
                </a:extLst>
              </a:tr>
              <a:tr h="821055">
                <a:tc>
                  <a:txBody>
                    <a:bodyPr/>
                    <a:lstStyle/>
                    <a:p>
                      <a:pPr algn="just"/>
                      <a:r>
                        <a:rPr lang="en-US" sz="9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Nutritional status and tooth</a:t>
                      </a:r>
                      <a:endParaRPr lang="de-DE" sz="1000" b="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Nutritional status was assessed with the help of body condition scoring. </a:t>
                      </a:r>
                      <a:endParaRPr lang="de-DE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algn="just"/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The mucous membranes and teeth were examined for discoloration or misalignment</a:t>
                      </a:r>
                      <a:endParaRPr lang="de-DE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0750283"/>
                  </a:ext>
                </a:extLst>
              </a:tr>
              <a:tr h="638175">
                <a:tc>
                  <a:txBody>
                    <a:bodyPr/>
                    <a:lstStyle/>
                    <a:p>
                      <a:pPr algn="just"/>
                      <a:r>
                        <a:rPr lang="en-US" sz="9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ovement behavior</a:t>
                      </a:r>
                      <a:endParaRPr lang="de-DE" sz="1000" b="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The movement behavior was observed for 5 minutes after opening the cage lid during cage change. Lameness or stereotypies were recorded</a:t>
                      </a:r>
                      <a:endParaRPr lang="de-DE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2307096"/>
                  </a:ext>
                </a:extLst>
              </a:tr>
              <a:tr h="527746">
                <a:tc>
                  <a:txBody>
                    <a:bodyPr/>
                    <a:lstStyle/>
                    <a:p>
                      <a:pPr algn="just"/>
                      <a:r>
                        <a:rPr lang="en-US" sz="9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Signs of pain</a:t>
                      </a:r>
                      <a:endParaRPr lang="de-DE" sz="1000" b="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Signs of pain were investigated during the cage change. The mouse grimace scale was recorded, as well as a raised back  </a:t>
                      </a:r>
                      <a:endParaRPr lang="de-DE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74523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endParaRPr lang="de-DE" sz="1000" b="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de-DE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6138041"/>
                  </a:ext>
                </a:extLst>
              </a:tr>
              <a:tr h="346075">
                <a:tc>
                  <a:txBody>
                    <a:bodyPr/>
                    <a:lstStyle/>
                    <a:p>
                      <a:pPr algn="just"/>
                      <a:r>
                        <a:rPr lang="en-US" sz="9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Social behavior</a:t>
                      </a:r>
                      <a:endParaRPr lang="de-DE" sz="1000" b="0" kern="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It was examined whether the animals separated or showed escape behavior</a:t>
                      </a:r>
                      <a:endParaRPr lang="de-DE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3744422"/>
                  </a:ext>
                </a:extLst>
              </a:tr>
            </a:tbl>
          </a:graphicData>
        </a:graphic>
      </p:graphicFrame>
      <p:sp>
        <p:nvSpPr>
          <p:cNvPr id="11" name="Rectangle 3">
            <a:extLst>
              <a:ext uri="{FF2B5EF4-FFF2-40B4-BE49-F238E27FC236}">
                <a16:creationId xmlns:a16="http://schemas.microsoft.com/office/drawing/2014/main" id="{CEDC09B9-7A56-BB40-A079-9F65D94B55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57300" y="372110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48797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8BF82D75-1D10-104D-BC1F-6E594720C5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9124070"/>
              </p:ext>
            </p:extLst>
          </p:nvPr>
        </p:nvGraphicFramePr>
        <p:xfrm>
          <a:off x="180975" y="1185970"/>
          <a:ext cx="6496050" cy="1502151"/>
        </p:xfrm>
        <a:graphic>
          <a:graphicData uri="http://schemas.openxmlformats.org/drawingml/2006/table">
            <a:tbl>
              <a:tblPr/>
              <a:tblGrid>
                <a:gridCol w="963484">
                  <a:extLst>
                    <a:ext uri="{9D8B030D-6E8A-4147-A177-3AD203B41FA5}">
                      <a16:colId xmlns:a16="http://schemas.microsoft.com/office/drawing/2014/main" val="1002664650"/>
                    </a:ext>
                  </a:extLst>
                </a:gridCol>
                <a:gridCol w="1434023">
                  <a:extLst>
                    <a:ext uri="{9D8B030D-6E8A-4147-A177-3AD203B41FA5}">
                      <a16:colId xmlns:a16="http://schemas.microsoft.com/office/drawing/2014/main" val="421184265"/>
                    </a:ext>
                  </a:extLst>
                </a:gridCol>
                <a:gridCol w="1025103">
                  <a:extLst>
                    <a:ext uri="{9D8B030D-6E8A-4147-A177-3AD203B41FA5}">
                      <a16:colId xmlns:a16="http://schemas.microsoft.com/office/drawing/2014/main" val="3138803584"/>
                    </a:ext>
                  </a:extLst>
                </a:gridCol>
                <a:gridCol w="689003">
                  <a:extLst>
                    <a:ext uri="{9D8B030D-6E8A-4147-A177-3AD203B41FA5}">
                      <a16:colId xmlns:a16="http://schemas.microsoft.com/office/drawing/2014/main" val="800112899"/>
                    </a:ext>
                  </a:extLst>
                </a:gridCol>
                <a:gridCol w="801036">
                  <a:extLst>
                    <a:ext uri="{9D8B030D-6E8A-4147-A177-3AD203B41FA5}">
                      <a16:colId xmlns:a16="http://schemas.microsoft.com/office/drawing/2014/main" val="3952824556"/>
                    </a:ext>
                  </a:extLst>
                </a:gridCol>
                <a:gridCol w="679668">
                  <a:extLst>
                    <a:ext uri="{9D8B030D-6E8A-4147-A177-3AD203B41FA5}">
                      <a16:colId xmlns:a16="http://schemas.microsoft.com/office/drawing/2014/main" val="3902993847"/>
                    </a:ext>
                  </a:extLst>
                </a:gridCol>
                <a:gridCol w="903733">
                  <a:extLst>
                    <a:ext uri="{9D8B030D-6E8A-4147-A177-3AD203B41FA5}">
                      <a16:colId xmlns:a16="http://schemas.microsoft.com/office/drawing/2014/main" val="1292772411"/>
                    </a:ext>
                  </a:extLst>
                </a:gridCol>
              </a:tblGrid>
              <a:tr h="130401"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aterial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urchase costs / kg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osts / year 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isposal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b</a:t>
                      </a:r>
                      <a:r>
                        <a:rPr lang="en-US" sz="800" b="0" i="0" u="none" strike="noStrike" noProof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uy-back</a:t>
                      </a:r>
                      <a:endParaRPr lang="en-US" sz="800" b="0" i="0" u="none" strike="noStrike" noProof="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avings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otal costs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8965986"/>
                  </a:ext>
                </a:extLst>
              </a:tr>
              <a:tr h="124474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970207"/>
                  </a:ext>
                </a:extLst>
              </a:tr>
              <a:tr h="243326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spen wood chips *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                                                                                  1.24 € 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                                              65,720,00 € 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3€ / kg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,590 €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7,310,00 €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0436360"/>
                  </a:ext>
                </a:extLst>
              </a:tr>
              <a:tr h="243326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C #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                                                                                17.91 € 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                                            184,508,00 € 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0€/kg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,242 €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76,266,40 €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0975521"/>
                  </a:ext>
                </a:extLst>
              </a:tr>
              <a:tr h="243326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C #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                                                                                17.91 € 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                                            184,508,00 € 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00€/kg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0,604 €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63,904,00 €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7718628"/>
                  </a:ext>
                </a:extLst>
              </a:tr>
              <a:tr h="243326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C '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                                                                                  4.90 € 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                                              50,479,80 € 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0€/kg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,242 €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2,238,20 €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9426753"/>
                  </a:ext>
                </a:extLst>
              </a:tr>
              <a:tr h="243326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C '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                                                                                  4.90 € 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                                              50,479,80 € 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00€/kg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0,604 €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9,875,80 €</a:t>
                      </a:r>
                    </a:p>
                  </a:txBody>
                  <a:tcPr marL="5105" marR="5105" marT="5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6632348"/>
                  </a:ext>
                </a:extLst>
              </a:tr>
            </a:tbl>
          </a:graphicData>
        </a:graphic>
      </p:graphicFrame>
      <p:sp>
        <p:nvSpPr>
          <p:cNvPr id="3" name="Rechteck 2">
            <a:extLst>
              <a:ext uri="{FF2B5EF4-FFF2-40B4-BE49-F238E27FC236}">
                <a16:creationId xmlns:a16="http://schemas.microsoft.com/office/drawing/2014/main" id="{B423B36D-2215-6C48-A38C-8D96E4B0AD7D}"/>
              </a:ext>
            </a:extLst>
          </p:cNvPr>
          <p:cNvSpPr/>
          <p:nvPr/>
        </p:nvSpPr>
        <p:spPr>
          <a:xfrm>
            <a:off x="90487" y="2836280"/>
            <a:ext cx="667702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600" dirty="0">
                <a:latin typeface="Palatino Linotype" panose="02040502050505030304" pitchFamily="18" charset="0"/>
              </a:rPr>
              <a:t>Assumption for example price calculation: </a:t>
            </a:r>
          </a:p>
          <a:p>
            <a:endParaRPr lang="en-US" sz="600" dirty="0">
              <a:latin typeface="Palatino Linotype" panose="02040502050505030304" pitchFamily="18" charset="0"/>
            </a:endParaRPr>
          </a:p>
          <a:p>
            <a:r>
              <a:rPr lang="en-US" sz="600" dirty="0">
                <a:latin typeface="Palatino Linotype" panose="02040502050505030304" pitchFamily="18" charset="0"/>
              </a:rPr>
              <a:t>Filling of 5000 cages once per week					</a:t>
            </a:r>
          </a:p>
          <a:p>
            <a:r>
              <a:rPr lang="en-US" sz="600" dirty="0">
                <a:latin typeface="Palatino Linotype" panose="02040502050505030304" pitchFamily="18" charset="0"/>
              </a:rPr>
              <a:t>Aspen wood chips:  200g/cage, no further re-use					</a:t>
            </a:r>
          </a:p>
          <a:p>
            <a:r>
              <a:rPr lang="en-US" sz="600" dirty="0">
                <a:latin typeface="Palatino Linotype" panose="02040502050505030304" pitchFamily="18" charset="0"/>
              </a:rPr>
              <a:t>Polycarbonate (PC): 680g/cage, 1% loss rate during processing, the original quantity is intended for three cleaning processes, durability of the material 1 year. 				</a:t>
            </a:r>
          </a:p>
          <a:p>
            <a:endParaRPr lang="en-US" sz="600" dirty="0">
              <a:latin typeface="Palatino Linotype" panose="02040502050505030304" pitchFamily="18" charset="0"/>
            </a:endParaRPr>
          </a:p>
          <a:p>
            <a:r>
              <a:rPr lang="en-US" sz="600" dirty="0">
                <a:latin typeface="Palatino Linotype" panose="02040502050505030304" pitchFamily="18" charset="0"/>
              </a:rPr>
              <a:t>Price calculation including four assumptions with different prices for material and buy-back during recycling:</a:t>
            </a:r>
          </a:p>
          <a:p>
            <a:r>
              <a:rPr lang="en-US" sz="600" dirty="0">
                <a:latin typeface="Palatino Linotype" panose="02040502050505030304" pitchFamily="18" charset="0"/>
              </a:rPr>
              <a:t>				</a:t>
            </a:r>
          </a:p>
          <a:p>
            <a:r>
              <a:rPr lang="en-US" sz="600" dirty="0">
                <a:latin typeface="Palatino Linotype" panose="02040502050505030304" pitchFamily="18" charset="0"/>
              </a:rPr>
              <a:t>*  53,000 kg/ year and disposal costs					</a:t>
            </a:r>
          </a:p>
          <a:p>
            <a:r>
              <a:rPr lang="en-US" sz="600" dirty="0">
                <a:latin typeface="Palatino Linotype" panose="02040502050505030304" pitchFamily="18" charset="0"/>
              </a:rPr>
              <a:t># 10,302 kg/ year,  high purchase costs of PC granules for the study, low buy-back costs according to stock exchange trading price					</a:t>
            </a:r>
          </a:p>
          <a:p>
            <a:r>
              <a:rPr lang="en-US" sz="600" dirty="0">
                <a:latin typeface="Palatino Linotype" panose="02040502050505030304" pitchFamily="18" charset="0"/>
              </a:rPr>
              <a:t># 10,302 kg/ year, high purchase costs of PC granules for the study, high buy-back costs according to stock exchange trading price					</a:t>
            </a:r>
          </a:p>
          <a:p>
            <a:r>
              <a:rPr lang="en-US" sz="600" dirty="0">
                <a:latin typeface="Palatino Linotype" panose="02040502050505030304" pitchFamily="18" charset="0"/>
              </a:rPr>
              <a:t>‘  10,302 kg/ year, purchase costs according to world market prices (incl. transportation, tax), lower buy-back costs according to stock exchange trading price			</a:t>
            </a:r>
          </a:p>
          <a:p>
            <a:r>
              <a:rPr lang="en-US" sz="600" dirty="0">
                <a:latin typeface="Palatino Linotype" panose="02040502050505030304" pitchFamily="18" charset="0"/>
              </a:rPr>
              <a:t>‘  10,302 kg/year, purchase price according to world market prices (incl. transportation, tax), high buy-back costs according to stock exchange trading price	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F5D3429F-6B67-CA4B-B79B-DC907AE46F23}"/>
              </a:ext>
            </a:extLst>
          </p:cNvPr>
          <p:cNvSpPr txBox="1"/>
          <p:nvPr/>
        </p:nvSpPr>
        <p:spPr>
          <a:xfrm>
            <a:off x="297035" y="145605"/>
            <a:ext cx="988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ble S3</a:t>
            </a:r>
          </a:p>
        </p:txBody>
      </p:sp>
    </p:spTree>
    <p:extLst>
      <p:ext uri="{BB962C8B-B14F-4D97-AF65-F5344CB8AC3E}">
        <p14:creationId xmlns:p14="http://schemas.microsoft.com/office/powerpoint/2010/main" val="3985119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87</Words>
  <Application>Microsoft Macintosh PowerPoint</Application>
  <PresentationFormat>A4-Papier (210 x 297 mm)</PresentationFormat>
  <Paragraphs>367</Paragraphs>
  <Slides>5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Palatino</vt:lpstr>
      <vt:lpstr>Palatino Linotype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Microsoft Office User</cp:lastModifiedBy>
  <cp:revision>7</cp:revision>
  <dcterms:created xsi:type="dcterms:W3CDTF">2025-01-13T14:17:30Z</dcterms:created>
  <dcterms:modified xsi:type="dcterms:W3CDTF">2025-01-29T08:58:10Z</dcterms:modified>
</cp:coreProperties>
</file>